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96F0201-D22A-4D55-AD72-EA9B3E22FB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5C2B7787-241A-4CA0-B5DC-1338A9CB41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4C70901-2C57-423C-B8C6-581683343E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F4827D-625A-41D0-B26C-ABDE1FCB80AD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FD5F843-CECF-4D49-85E1-79BA93BC5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86D1EBC-270A-4FE0-B009-B9DFA7112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AEC7E-B33B-4E4C-BAC4-051C0116702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980437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422DB6A-C595-4C8F-9AE8-7FD802654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7D2E8B0-B2E8-422D-93EF-3F565EC794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D08F6F5-32E5-4E16-AD73-62B8789A0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F4827D-625A-41D0-B26C-ABDE1FCB80AD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4D23CB2-197E-4D09-8A8F-E8B50CF7D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0063545-A033-4DF8-8DF3-40E7CB6D8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AEC7E-B33B-4E4C-BAC4-051C0116702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280090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EBF48C3C-9656-48DA-B8E7-920AE5978E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5C58C0D-0B91-4C5C-8D30-78982632E6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00B90F5-B3E9-424C-9A53-D2F5FBA45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F4827D-625A-41D0-B26C-ABDE1FCB80AD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47FE343-3A6E-4304-BBAA-7B90B211D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F6D6841-3122-4B02-918C-4DB0AD206B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AEC7E-B33B-4E4C-BAC4-051C0116702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97358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1C8DE03-4342-4DDE-889F-42B0714F40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3070E16-DA56-42ED-AE41-A9A01DBE65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09BC2B7-151D-434D-B5AC-E521F0716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F4827D-625A-41D0-B26C-ABDE1FCB80AD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6BE35BC-58DC-47DB-9DCF-74D0FD605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ACDC860-534D-4D24-9179-CEBEE5ADAA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AEC7E-B33B-4E4C-BAC4-051C0116702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86702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BC6AFA1-8AD4-4649-A29F-6FC6161FB6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885B64F-6DF8-433C-839D-1178E69FE5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4718352-2A5A-478D-A9A2-CA868C9E1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F4827D-625A-41D0-B26C-ABDE1FCB80AD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879D3E8-7BF9-4D7B-AC2A-ABD659ED1F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F2A11FD-7639-47AF-BC4A-C66F685D6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AEC7E-B33B-4E4C-BAC4-051C0116702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49886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50B840D-972C-4CFA-8582-E1B5BC9080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ADE7C36-2D04-4EFB-8CB3-9AC686FBA5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4A6D8F7-957E-401F-8EA5-B4312E6B3A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FF3BF0F-B5D0-42E9-89E5-47C972B60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F4827D-625A-41D0-B26C-ABDE1FCB80AD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F0B156D-C70F-46FC-945D-0C92727C94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A4AA796-EBB6-4A2B-BEA1-2890E0D84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AEC7E-B33B-4E4C-BAC4-051C0116702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43328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98CD041-B285-4309-A6A5-FE7676EB0C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5060979-24B7-418E-8E55-8B2C2DF550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E443D67-5133-417F-BA33-FC093EBCC2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F2ADD2D6-13FD-41B8-BC0A-8E41AE55E4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3F089FF0-EE4D-4A74-A0E6-ED56E352B1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B76EED3F-2074-4B70-B336-03F2403E7B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F4827D-625A-41D0-B26C-ABDE1FCB80AD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4A9CBDF-9873-43DE-9862-9BEB0C590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F831D13C-0092-493A-BBFC-7D8FF40F58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AEC7E-B33B-4E4C-BAC4-051C0116702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77292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7FE2ED0-7363-440C-9AD4-B791B56490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FAB789DA-2634-4026-925E-5950EECF5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F4827D-625A-41D0-B26C-ABDE1FCB80AD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F301FFF0-76A5-4BEF-9A77-4CF34AB631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FF040F99-1B8D-4C1E-B42B-01AA75E93C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AEC7E-B33B-4E4C-BAC4-051C0116702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85051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F73E44E-855A-4815-8760-528741C74B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F4827D-625A-41D0-B26C-ABDE1FCB80AD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C7423616-50C6-4477-BAAF-E07D1B791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7D1CE583-71BB-49D2-A684-65A45DA3B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AEC7E-B33B-4E4C-BAC4-051C0116702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36173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7CBD50D-E51B-4888-8F0B-710AF16F5B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5E59CF1-6E78-49BD-995A-BB1F7AF75E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88DCC8B-E489-4EF4-8BCF-22633E54D8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EDAF48A-9FF1-4693-B491-421976E9D9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F4827D-625A-41D0-B26C-ABDE1FCB80AD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B6F0433-79C6-4229-97B1-39B468A1F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CB9DC9C-9223-4F83-B13C-0D3F212B8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AEC7E-B33B-4E4C-BAC4-051C0116702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201375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0DB65B2-D1CD-401D-AEFE-DC2C7C0A5B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F8D18AAE-E297-4E49-B928-E13FF862EB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73C843E-6008-4078-9CB2-24155DEEF3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3C2ABAE-E4C5-4616-A25D-D8411B260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F4827D-625A-41D0-B26C-ABDE1FCB80AD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E863A62-2A62-4343-84B5-C79302ADC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BC12F3C-BDB5-47B1-92D6-0E6DF916B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9AEC7E-B33B-4E4C-BAC4-051C0116702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38248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6D695DA-CEA7-4430-B454-B8D81384D2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F345463-ABA0-4221-88EB-3F8B70FE51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ACE7D70-6F95-404D-B367-9F027745DB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F4827D-625A-41D0-B26C-ABDE1FCB80AD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2F77BB7-8628-4DA7-B111-AAC13487AE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F7DBA22-44E1-4C95-ABA8-4746D8F198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9AEC7E-B33B-4E4C-BAC4-051C0116702A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56317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62D68292-E144-4794-BC0F-CE6BCA091865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4200" y="515167"/>
            <a:ext cx="5943600" cy="3371850"/>
          </a:xfrm>
          <a:prstGeom prst="rect">
            <a:avLst/>
          </a:prstGeom>
        </p:spPr>
      </p:pic>
      <p:sp>
        <p:nvSpPr>
          <p:cNvPr id="5" name="Rectángulo 4">
            <a:extLst>
              <a:ext uri="{FF2B5EF4-FFF2-40B4-BE49-F238E27FC236}">
                <a16:creationId xmlns:a16="http://schemas.microsoft.com/office/drawing/2014/main" id="{47D1D774-24EB-44B9-95C7-DB02BFA71E7E}"/>
              </a:ext>
            </a:extLst>
          </p:cNvPr>
          <p:cNvSpPr/>
          <p:nvPr/>
        </p:nvSpPr>
        <p:spPr>
          <a:xfrm>
            <a:off x="3048000" y="4458176"/>
            <a:ext cx="6096000" cy="830997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ysM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ffectors from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. atroviride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genome of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. atrovirid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des for six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ys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ffectors of varying number of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ys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tifs. The distribution of the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ys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tifs for each effector is showed as gray cylinders, and the signal peptide is represented by the initial dot.</a:t>
            </a:r>
            <a:endParaRPr lang="es-MX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206949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ulina Guzmán Guzmán</dc:creator>
  <cp:lastModifiedBy>Paulina Guzmán Guzmán</cp:lastModifiedBy>
  <cp:revision>1</cp:revision>
  <dcterms:created xsi:type="dcterms:W3CDTF">2019-09-06T14:35:06Z</dcterms:created>
  <dcterms:modified xsi:type="dcterms:W3CDTF">2019-09-06T14:35:44Z</dcterms:modified>
</cp:coreProperties>
</file>